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9" r:id="rId3"/>
    <p:sldId id="270" r:id="rId4"/>
    <p:sldId id="257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3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803C6A-0731-C85A-6BF9-5619302FBA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873D788-CE2F-7221-34B3-A220EF923E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9ED603-89C5-C246-71F6-6E67CD2BC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4AD11B-BE20-D503-4AC8-3C9EFA6D8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EFD1E8-D829-A49F-D4D2-A37ADBE24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6716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49B981-D613-8895-F129-A9A4BE4E8E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9251CAD-FEEA-085F-270C-8F8DE58DFA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0184D8-D59F-F446-EC7F-EDFEF3DDC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D8F485-CB31-1BBC-7FD0-E0A4A71C9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07330A-FC18-893F-B8CF-E038DF0A2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9588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D868C14-BCE6-EA94-C605-FA3E06D90A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B66E0E5-5FD5-1DDA-C2B4-2960A8804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C2CBAD-1C24-6ACC-DBF3-2226AEFA3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E10F39-3DE3-5126-3CAA-C569770C5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771157-3DA9-29E6-E6AC-303BD5AA7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4671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34DB50-94F8-C145-2DAD-065BE68EF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92CF8A0-2B2D-2F07-33CD-6C5D117F06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F407A2-10C2-0D14-A202-643784E54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036653-2459-BFF9-AF37-5B534EF1C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B6A4A27-5641-9355-C8FA-E516DB26B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3882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C9D1C9-A2F3-45F5-C675-06A99BAB1C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517E328-BEC7-48F2-61C6-0FF44B03EC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AF8E75-C25C-A80A-92C8-947C548CD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4831BB-ACFE-CE43-597C-8B9181A79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727B03-D155-6483-7321-B33076151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9728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B2599E-800B-F420-A8C8-BB9E9DC2B9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51B72AA-673C-66D3-A00A-64442F2F85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AE9370B-75AA-C6B8-CF44-95561AEDB3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2925770-BA57-0872-8E71-336A6130E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2A25FE0-2F75-3702-B3A3-C4CAEE46C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17E827-C429-A35C-1C16-A71C35FA0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6967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6DB9C0-430C-49A2-DC31-76A169D04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1F94F44-EC20-1265-1909-70C405FF8B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0A6D5A5-732F-092A-D761-CE802A6A99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551D606-7692-16FC-79FB-9E2F390014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0D7CAA3-E971-905D-CBAA-1C16FD29AD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9233AA3-ED2D-E031-3748-E845148EC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A1308FA-8DBE-11ED-F5DC-F7CAB9034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941C37B-3431-079C-9F26-179CDDAC2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5794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6AC303-3603-99B9-8531-D81EF1D2F7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2D3A7F0-AF52-3506-1D3C-F3D7428A2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C778114-83A8-190F-C41F-483C58012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293D6BF-B2EE-E3D9-6852-C1053CCC1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1563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D7B6F42-BA72-C0C3-CB01-89CE69CEF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1CFE492-A03A-BC29-F8D3-1F7B28B87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97735CA-BAFC-11C0-F017-6E29A33E4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7254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24227A-203A-D861-2B5C-1B8E973A91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6477B5E-3821-756C-2B59-36C90D74E5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80F51E4-2980-EE2A-7A89-8B4EEF3186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9DF67FE-D3FC-5CF8-12DF-78D684F516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C2133BB-551A-5FBD-CE31-832FD0499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AB3ECE6-FC1B-7079-CE93-49DABC83A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7004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1AFC6A-545E-CF86-5513-72C8A7282B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E3303E1-41BA-6824-0FDE-8F7DBC4C6B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F3C75B3-634A-F993-0477-03C7DFF724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2484013-4577-0E29-0CE0-8175D4C56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1D5D11-DDD6-46F5-00F0-85C89BE94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34E74F-28AF-8CA7-6373-792C2F564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8053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3124CFA-7A63-A16D-5AD2-DE1F3CC41A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E317A43-022E-16D9-64CA-028C4C05D6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1EE260E-86AA-3D15-23EA-8E4B07E1E3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A9035A-5041-46CC-8611-5E0DB4CD43AD}" type="datetimeFigureOut">
              <a:rPr lang="zh-CN" altLang="en-US" smtClean="0"/>
              <a:t>2025/10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2AA5F8-145B-5A14-CB86-B1F8135484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81EF5C-057E-3147-F655-6CE5156B78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556F8E-5453-4E33-8FE9-9872B3F5A4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4883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emf"/><Relationship Id="rId4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3D2F9FFD-B9B2-A042-3A15-2228D0B1687D}"/>
              </a:ext>
            </a:extLst>
          </p:cNvPr>
          <p:cNvGrpSpPr/>
          <p:nvPr/>
        </p:nvGrpSpPr>
        <p:grpSpPr>
          <a:xfrm>
            <a:off x="6275388" y="977900"/>
            <a:ext cx="3989387" cy="3611563"/>
            <a:chOff x="6275388" y="977900"/>
            <a:chExt cx="3989387" cy="3611563"/>
          </a:xfrm>
        </p:grpSpPr>
        <p:graphicFrame>
          <p:nvGraphicFramePr>
            <p:cNvPr id="2" name="对象 1">
              <a:extLst>
                <a:ext uri="{FF2B5EF4-FFF2-40B4-BE49-F238E27FC236}">
                  <a16:creationId xmlns:a16="http://schemas.microsoft.com/office/drawing/2014/main" id="{7D05E432-65FC-3EF7-ADEA-892B944B85A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42282719"/>
                </p:ext>
              </p:extLst>
            </p:nvPr>
          </p:nvGraphicFramePr>
          <p:xfrm>
            <a:off x="6275388" y="977900"/>
            <a:ext cx="3989387" cy="36115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988871" imgH="3611817" progId="Prism10.Document">
                    <p:embed/>
                  </p:oleObj>
                </mc:Choice>
                <mc:Fallback>
                  <p:oleObj name="Prism 10" r:id="rId2" imgW="3988871" imgH="3611817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275388" y="977900"/>
                          <a:ext cx="3989387" cy="36115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0FAA9DE9-F721-42FA-E708-53C6BD622FB7}"/>
                </a:ext>
              </a:extLst>
            </p:cNvPr>
            <p:cNvSpPr txBox="1"/>
            <p:nvPr/>
          </p:nvSpPr>
          <p:spPr>
            <a:xfrm>
              <a:off x="7573034" y="4012129"/>
              <a:ext cx="26808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nti-CD3-U27 cells: PBMCs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582EFCB3-E57D-782F-5693-C5B041F4697D}"/>
              </a:ext>
            </a:extLst>
          </p:cNvPr>
          <p:cNvGrpSpPr/>
          <p:nvPr/>
        </p:nvGrpSpPr>
        <p:grpSpPr>
          <a:xfrm>
            <a:off x="1428750" y="977900"/>
            <a:ext cx="4267558" cy="3342006"/>
            <a:chOff x="1428750" y="977900"/>
            <a:chExt cx="4267558" cy="3342006"/>
          </a:xfrm>
        </p:grpSpPr>
        <p:graphicFrame>
          <p:nvGraphicFramePr>
            <p:cNvPr id="3" name="对象 2">
              <a:extLst>
                <a:ext uri="{FF2B5EF4-FFF2-40B4-BE49-F238E27FC236}">
                  <a16:creationId xmlns:a16="http://schemas.microsoft.com/office/drawing/2014/main" id="{D82D105F-F91F-AF7F-9029-7FF0DA0856C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40823583"/>
                </p:ext>
              </p:extLst>
            </p:nvPr>
          </p:nvGraphicFramePr>
          <p:xfrm>
            <a:off x="1428750" y="977900"/>
            <a:ext cx="3984625" cy="3187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984192" imgH="3188104" progId="Prism10.Document">
                    <p:embed/>
                  </p:oleObj>
                </mc:Choice>
                <mc:Fallback>
                  <p:oleObj name="Prism 10" r:id="rId4" imgW="3984192" imgH="3188104" progId="Prism10.Document">
                    <p:embed/>
                    <p:pic>
                      <p:nvPicPr>
                        <p:cNvPr id="2" name="对象 1">
                          <a:extLst>
                            <a:ext uri="{FF2B5EF4-FFF2-40B4-BE49-F238E27FC236}">
                              <a16:creationId xmlns:a16="http://schemas.microsoft.com/office/drawing/2014/main" id="{D82D105F-F91F-AF7F-9029-7FF0DA0856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428750" y="977900"/>
                          <a:ext cx="3984625" cy="3187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09DA985-AC14-B65B-0CB8-5303CE5CDA44}"/>
                </a:ext>
              </a:extLst>
            </p:cNvPr>
            <p:cNvSpPr txBox="1"/>
            <p:nvPr/>
          </p:nvSpPr>
          <p:spPr>
            <a:xfrm>
              <a:off x="3015411" y="4012129"/>
              <a:ext cx="26808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U27 cells: PBMCs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965092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/>
          <p:nvPr>
            <p:extLst>
              <p:ext uri="{D42A27DB-BD31-4B8C-83A1-F6EECF244321}">
                <p14:modId xmlns:p14="http://schemas.microsoft.com/office/powerpoint/2010/main" val="3661165104"/>
              </p:ext>
            </p:extLst>
          </p:nvPr>
        </p:nvGraphicFramePr>
        <p:xfrm>
          <a:off x="4117404" y="1470406"/>
          <a:ext cx="2841625" cy="298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028950" imgH="3175000" progId="Prism8.Document">
                  <p:embed/>
                </p:oleObj>
              </mc:Choice>
              <mc:Fallback>
                <p:oleObj name="Prism 8" r:id="rId2" imgW="3028950" imgH="3175000" progId="Prism8.Document">
                  <p:embed/>
                  <p:pic>
                    <p:nvPicPr>
                      <p:cNvPr id="2" name="对象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17404" y="1470406"/>
                        <a:ext cx="2841625" cy="298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E8450EE4-784F-5E33-7FE8-907DBA7E55B2}"/>
              </a:ext>
            </a:extLst>
          </p:cNvPr>
          <p:cNvGrpSpPr/>
          <p:nvPr/>
        </p:nvGrpSpPr>
        <p:grpSpPr>
          <a:xfrm>
            <a:off x="403012" y="853611"/>
            <a:ext cx="4869859" cy="3448096"/>
            <a:chOff x="403012" y="853611"/>
            <a:chExt cx="4869859" cy="3448096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DB10912A-45F8-7354-F9FE-4501FDCBD8A1}"/>
                </a:ext>
              </a:extLst>
            </p:cNvPr>
            <p:cNvGrpSpPr/>
            <p:nvPr/>
          </p:nvGrpSpPr>
          <p:grpSpPr>
            <a:xfrm>
              <a:off x="403012" y="853611"/>
              <a:ext cx="4600360" cy="3448096"/>
              <a:chOff x="403012" y="853611"/>
              <a:chExt cx="4600360" cy="3448096"/>
            </a:xfrm>
          </p:grpSpPr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B9B7B533-B704-EF54-A91C-094D2BBAF7BB}"/>
                  </a:ext>
                </a:extLst>
              </p:cNvPr>
              <p:cNvSpPr txBox="1"/>
              <p:nvPr/>
            </p:nvSpPr>
            <p:spPr>
              <a:xfrm>
                <a:off x="403012" y="3614399"/>
                <a:ext cx="14358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U27 cells: PBMCs)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B55BE347-6291-16B3-E678-981C42EAE431}"/>
                  </a:ext>
                </a:extLst>
              </p:cNvPr>
              <p:cNvSpPr txBox="1"/>
              <p:nvPr/>
            </p:nvSpPr>
            <p:spPr>
              <a:xfrm>
                <a:off x="858329" y="3801474"/>
                <a:ext cx="85545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27 cells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46A971BC-F91B-09C4-713F-502883D40220}"/>
                  </a:ext>
                </a:extLst>
              </p:cNvPr>
              <p:cNvSpPr txBox="1"/>
              <p:nvPr/>
            </p:nvSpPr>
            <p:spPr>
              <a:xfrm>
                <a:off x="436382" y="3988549"/>
                <a:ext cx="1454989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anine PBMCs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E9D2ED1E-B682-FA56-BD46-26B24D9AD309}"/>
                  </a:ext>
                </a:extLst>
              </p:cNvPr>
              <p:cNvSpPr txBox="1"/>
              <p:nvPr/>
            </p:nvSpPr>
            <p:spPr>
              <a:xfrm>
                <a:off x="1704539" y="3801474"/>
                <a:ext cx="3298833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+         +         +       +        +        +         +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84D81B0B-6D86-6ACE-8A17-6100173FA98D}"/>
                  </a:ext>
                </a:extLst>
              </p:cNvPr>
              <p:cNvSpPr txBox="1"/>
              <p:nvPr/>
            </p:nvSpPr>
            <p:spPr>
              <a:xfrm>
                <a:off x="1699439" y="4024708"/>
                <a:ext cx="302848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-         +         +       +        +        +         +         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5F769619-6954-D4D9-DF50-3381B8AAC951}"/>
                  </a:ext>
                </a:extLst>
              </p:cNvPr>
              <p:cNvSpPr txBox="1"/>
              <p:nvPr/>
            </p:nvSpPr>
            <p:spPr>
              <a:xfrm>
                <a:off x="616789" y="853611"/>
                <a:ext cx="48307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4" name="对象 3">
              <a:extLst>
                <a:ext uri="{FF2B5EF4-FFF2-40B4-BE49-F238E27FC236}">
                  <a16:creationId xmlns:a16="http://schemas.microsoft.com/office/drawing/2014/main" id="{51BFF56E-5E59-50EA-C25A-FFA9A4AD88A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61278733"/>
                </p:ext>
              </p:extLst>
            </p:nvPr>
          </p:nvGraphicFramePr>
          <p:xfrm>
            <a:off x="880258" y="1154113"/>
            <a:ext cx="4392613" cy="28114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4392688" imgH="2811911" progId="Prism10.Document">
                    <p:embed/>
                  </p:oleObj>
                </mc:Choice>
                <mc:Fallback>
                  <p:oleObj name="Prism 10" r:id="rId2" imgW="4392688" imgH="2811911" progId="Prism10.Document">
                    <p:embed/>
                    <p:pic>
                      <p:nvPicPr>
                        <p:cNvPr id="17" name="对象 16">
                          <a:extLst>
                            <a:ext uri="{FF2B5EF4-FFF2-40B4-BE49-F238E27FC236}">
                              <a16:creationId xmlns:a16="http://schemas.microsoft.com/office/drawing/2014/main" id="{D1F9B80E-7BAD-ED9D-E867-37A759F241A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880258" y="1154113"/>
                          <a:ext cx="4392613" cy="28114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4D559A5C-6DBD-AABF-5A85-7831C389AEEF}"/>
              </a:ext>
            </a:extLst>
          </p:cNvPr>
          <p:cNvGrpSpPr/>
          <p:nvPr/>
        </p:nvGrpSpPr>
        <p:grpSpPr>
          <a:xfrm>
            <a:off x="5079818" y="880528"/>
            <a:ext cx="5643521" cy="3424056"/>
            <a:chOff x="5079818" y="880528"/>
            <a:chExt cx="5643521" cy="3424056"/>
          </a:xfrm>
        </p:grpSpPr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5B9E87F3-2F4D-EA8F-7B96-0E488DC86C01}"/>
                </a:ext>
              </a:extLst>
            </p:cNvPr>
            <p:cNvGrpSpPr/>
            <p:nvPr/>
          </p:nvGrpSpPr>
          <p:grpSpPr>
            <a:xfrm>
              <a:off x="5079818" y="880528"/>
              <a:ext cx="5253231" cy="3424056"/>
              <a:chOff x="5079818" y="880528"/>
              <a:chExt cx="5253231" cy="3424056"/>
            </a:xfrm>
          </p:grpSpPr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24EC426A-BB44-B3DD-DBE9-6C9FDCB122A7}"/>
                  </a:ext>
                </a:extLst>
              </p:cNvPr>
              <p:cNvSpPr txBox="1"/>
              <p:nvPr/>
            </p:nvSpPr>
            <p:spPr>
              <a:xfrm>
                <a:off x="5079818" y="3606927"/>
                <a:ext cx="268089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nti-CD3-U27 cells: PBMCs)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D53EBFBD-4719-A1E2-7654-65313B7BFDD6}"/>
                  </a:ext>
                </a:extLst>
              </p:cNvPr>
              <p:cNvSpPr txBox="1"/>
              <p:nvPr/>
            </p:nvSpPr>
            <p:spPr>
              <a:xfrm>
                <a:off x="5542371" y="3804351"/>
                <a:ext cx="155284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nti-CD3-U27 cells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6E98FF61-6EC1-A08F-2CC2-D641886CDAF4}"/>
                  </a:ext>
                </a:extLst>
              </p:cNvPr>
              <p:cNvSpPr txBox="1"/>
              <p:nvPr/>
            </p:nvSpPr>
            <p:spPr>
              <a:xfrm>
                <a:off x="5806316" y="3991426"/>
                <a:ext cx="1454989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anine PBMCs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1E6DCF29-5995-7224-3C66-5B9DA2E6E591}"/>
                  </a:ext>
                </a:extLst>
              </p:cNvPr>
              <p:cNvSpPr txBox="1"/>
              <p:nvPr/>
            </p:nvSpPr>
            <p:spPr>
              <a:xfrm>
                <a:off x="7034216" y="3804351"/>
                <a:ext cx="3298833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+         +         +        +         +        +         +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48DA3359-F0D4-68C1-5822-609E1691B574}"/>
                  </a:ext>
                </a:extLst>
              </p:cNvPr>
              <p:cNvSpPr txBox="1"/>
              <p:nvPr/>
            </p:nvSpPr>
            <p:spPr>
              <a:xfrm>
                <a:off x="7029116" y="4027585"/>
                <a:ext cx="320756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-         +         +        +         +        +         +         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8CD75E75-FD24-5EE5-E95D-9DEF468B7752}"/>
                  </a:ext>
                </a:extLst>
              </p:cNvPr>
              <p:cNvSpPr txBox="1"/>
              <p:nvPr/>
            </p:nvSpPr>
            <p:spPr>
              <a:xfrm>
                <a:off x="5814149" y="880528"/>
                <a:ext cx="48307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13" name="对象 12">
              <a:extLst>
                <a:ext uri="{FF2B5EF4-FFF2-40B4-BE49-F238E27FC236}">
                  <a16:creationId xmlns:a16="http://schemas.microsoft.com/office/drawing/2014/main" id="{A3EA9794-BC9D-2793-A132-EABBBA3AEDE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29315832"/>
                </p:ext>
              </p:extLst>
            </p:nvPr>
          </p:nvGraphicFramePr>
          <p:xfrm>
            <a:off x="6183089" y="1111552"/>
            <a:ext cx="4540250" cy="2800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4540251" imgH="2801111" progId="Prism10.Document">
                    <p:embed/>
                  </p:oleObj>
                </mc:Choice>
                <mc:Fallback>
                  <p:oleObj name="Prism 10" r:id="rId4" imgW="4540251" imgH="2801111" progId="Prism10.Document">
                    <p:embed/>
                    <p:pic>
                      <p:nvPicPr>
                        <p:cNvPr id="25" name="对象 24">
                          <a:extLst>
                            <a:ext uri="{FF2B5EF4-FFF2-40B4-BE49-F238E27FC236}">
                              <a16:creationId xmlns:a16="http://schemas.microsoft.com/office/drawing/2014/main" id="{7CE59009-B994-A184-18D5-CFDAE61D394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183089" y="1111552"/>
                          <a:ext cx="4540250" cy="2800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8777505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83B9725F-A099-4AB4-7CCD-516B52BA975C}"/>
              </a:ext>
            </a:extLst>
          </p:cNvPr>
          <p:cNvGrpSpPr/>
          <p:nvPr/>
        </p:nvGrpSpPr>
        <p:grpSpPr>
          <a:xfrm>
            <a:off x="341165" y="506630"/>
            <a:ext cx="11610043" cy="3160114"/>
            <a:chOff x="341165" y="506630"/>
            <a:chExt cx="11610043" cy="3160114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17C8D630-AEAB-1520-47FD-BDD269D12681}"/>
                </a:ext>
              </a:extLst>
            </p:cNvPr>
            <p:cNvGrpSpPr/>
            <p:nvPr/>
          </p:nvGrpSpPr>
          <p:grpSpPr>
            <a:xfrm>
              <a:off x="8448818" y="506630"/>
              <a:ext cx="3502390" cy="3160114"/>
              <a:chOff x="8403098" y="506631"/>
              <a:chExt cx="3262763" cy="2984653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23287645-68E6-F4FB-18FF-996EFB9914A2}"/>
                  </a:ext>
                </a:extLst>
              </p:cNvPr>
              <p:cNvSpPr txBox="1"/>
              <p:nvPr/>
            </p:nvSpPr>
            <p:spPr>
              <a:xfrm>
                <a:off x="8403098" y="506631"/>
                <a:ext cx="417817" cy="2906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7CAB4004-4F17-2292-77EB-6EDA0A7034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820915" y="506631"/>
                <a:ext cx="2844946" cy="2984653"/>
              </a:xfrm>
              <a:prstGeom prst="rect">
                <a:avLst/>
              </a:prstGeom>
            </p:spPr>
          </p:pic>
        </p:grp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953DF94E-F6CF-75A5-F910-A8262796F64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1165" y="506631"/>
              <a:ext cx="4002235" cy="2880207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14FCA91F-0A6F-1D9E-16D2-A33615C60D9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25153" y="506630"/>
              <a:ext cx="4662712" cy="288020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18965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69</Words>
  <Application>Microsoft Office PowerPoint</Application>
  <PresentationFormat>宽屏</PresentationFormat>
  <Paragraphs>15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rism 10</vt:lpstr>
      <vt:lpstr>GraphPad Prism 8 Project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ngjuan chen</dc:creator>
  <cp:lastModifiedBy>2050763078@qq.com</cp:lastModifiedBy>
  <cp:revision>15</cp:revision>
  <dcterms:created xsi:type="dcterms:W3CDTF">2025-04-27T13:56:41Z</dcterms:created>
  <dcterms:modified xsi:type="dcterms:W3CDTF">2025-10-11T12:46:50Z</dcterms:modified>
</cp:coreProperties>
</file>